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75" r:id="rId3"/>
    <p:sldId id="259" r:id="rId4"/>
    <p:sldId id="267" r:id="rId5"/>
    <p:sldId id="263" r:id="rId6"/>
    <p:sldId id="261" r:id="rId7"/>
    <p:sldId id="265" r:id="rId8"/>
    <p:sldId id="273" r:id="rId9"/>
    <p:sldId id="269" r:id="rId10"/>
    <p:sldId id="271" r:id="rId11"/>
    <p:sldId id="281" r:id="rId12"/>
    <p:sldId id="283" r:id="rId13"/>
    <p:sldId id="282" r:id="rId14"/>
    <p:sldId id="292" r:id="rId15"/>
    <p:sldId id="276" r:id="rId16"/>
    <p:sldId id="288" r:id="rId17"/>
    <p:sldId id="289" r:id="rId18"/>
    <p:sldId id="293" r:id="rId19"/>
    <p:sldId id="277" r:id="rId20"/>
    <p:sldId id="291" r:id="rId21"/>
    <p:sldId id="278" r:id="rId22"/>
    <p:sldId id="287" r:id="rId23"/>
    <p:sldId id="258" r:id="rId24"/>
    <p:sldId id="279" r:id="rId25"/>
    <p:sldId id="284" r:id="rId26"/>
    <p:sldId id="285" r:id="rId27"/>
    <p:sldId id="286" r:id="rId28"/>
    <p:sldId id="290" r:id="rId2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4DDBC08-A37D-42A2-9130-FFCD509B9E1E}" v="1" dt="2023-04-04T09:11:35.0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7" d="100"/>
          <a:sy n="77" d="100"/>
        </p:scale>
        <p:origin x="192" y="3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presProps" Target="presProps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54CD7-7223-615B-9DDD-6B59C656A1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4FED14-2487-E1D5-CA82-0B7094D8E4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0C1AA1-0F05-12F2-FEDC-5B957851E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BB9C26-6350-7D39-A21E-B339E0742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934B2D-5115-F7FB-7257-FD681D4CC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98530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AC938-3F1A-5C72-02F0-B8F893B7E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E45DA4-40F4-919D-B8AB-C753DD0719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CC3CC0-6424-495A-7F38-1F0D81C34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76D3C-1BBE-9B71-9429-A87860E6A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2D654A-E7D1-2255-2CE9-FD47E13D30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6285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F278C9-0E54-583F-A4D9-6E4F13E6B7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603CFA-F2AB-F56E-2A05-CDFB77228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45E35-49EE-1CAE-4B2C-69D9D75A8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A72502-EB9D-9B75-3CD4-9CBFDB258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AFFEFE-F31F-986D-ED72-EE3B5CD84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30296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9BFD3-6AF3-8292-9457-F36EB0A3D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8F8B77-28A3-B99C-1E34-EB79831C2F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530D9-648C-5EB4-438D-B767B4ABE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A43B07-EC56-89B7-7012-7AA71101A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9F609B-F2D5-5358-7133-798C53E5CE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97226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311B97-8019-69D1-FF18-663EB352E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39AFD9-5661-1536-F323-6ED578D951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863DC-D5CD-6E9D-3C98-984313654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C449A5-13BC-046A-BA63-F553BC9F3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1065DD-D8E5-F4BF-C6B4-046BEFCB9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07169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210A82-2885-D278-1B19-5C8D006999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81ED3D-F248-3EB5-0AB1-13569C8D7D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5EB4B6-B27E-1A39-ECCA-C35C425359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957127-F6A0-F90E-1249-BE9FC8EF64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FAA0B8-520B-BF84-4417-FAE5868E9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E0AB0-5553-C276-E4A2-DA1AB7D43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35288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9B870E-677B-9D3C-72B7-E149A05DA1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A762B8-D6A2-553E-964F-4B905D3DA6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9FD830-7058-7701-B04A-5984A0F2F1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6F07FA-6225-2190-C4D5-D16352F2F2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F290BA-97FB-8016-383F-BFD4416FE8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95C6A7-13BB-0FE3-8030-52D834ADA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747FFF-67C4-B9A2-ADC1-0E415C8AF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776CC6-D413-6572-1CAC-BD267AB80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37138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4EDB5-2A98-09A7-067C-C74624D6D0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24EF38-285E-CFA3-CFCA-AD75C5D9D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95F219-AC6C-D906-D64D-7A50A7970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51FAFE-0A9C-0633-930C-22D0CB9D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82216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98A9EFA-9797-70BE-711E-4CD9F3323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852E11-FFFB-CEB3-0E6C-2FA8FEF0C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4A976C-9CC7-6FAF-78A5-A794FBDF7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80030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ADDFCB-5D4D-DC2F-70CA-DBAF3335B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946391-BD15-C60F-25E4-35B2766166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19FBE0-C174-014B-7180-BD290547B9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F3108A-4105-D103-A332-C3D5DB820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B9DBF4-DA5E-8FB1-4441-DC9F36E53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E90E64-0E63-67C4-AC46-408797A32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28539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1B1E9D-1A6D-68BF-65A0-A2D3932A4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B1F350-4898-B8E9-2EBB-A24BFC432C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4407DC-E046-10F8-EABB-A8E8B1BE76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9B02A1-5008-A036-416A-70342789C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2770D-E9D1-48F4-E722-FEEBA96DF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FBF03D-70ED-FD61-0BF4-E0C3845E9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5598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900E16B-EB41-4830-4422-65578B149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361B36-EDE1-F932-B055-381A7B5C6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00DAC3-C893-0F57-C1EF-78D218CEB1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00742B-CC5D-4185-A6F9-335B7DE407D8}" type="datetimeFigureOut">
              <a:rPr lang="en-ZA" smtClean="0"/>
              <a:t>2023/04/10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9DCBCD-8641-D9C9-DBA4-9042B3FAEC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4DC423-01E6-7BA5-F1E5-71901FBC84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497B8B-DBBE-4464-A30C-5140178E379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97008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6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45C85-CE05-A9A9-D9FC-D74C549B7C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493513"/>
            <a:ext cx="9144000" cy="1870974"/>
          </a:xfrm>
        </p:spPr>
        <p:txBody>
          <a:bodyPr/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ests and Screening activity cards</a:t>
            </a:r>
            <a:endParaRPr lang="en-Z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80628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7" name="Rectangle 5126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6B4E5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cal Health Screening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9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22" name="Picture 2" descr="Health Screening | Different Types of Health Screening">
            <a:extLst>
              <a:ext uri="{FF2B5EF4-FFF2-40B4-BE49-F238E27FC236}">
                <a16:creationId xmlns:a16="http://schemas.microsoft.com/office/drawing/2014/main" id="{3FCFE831-4036-D009-FEF0-1E0C2C53AB7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80"/>
          <a:stretch/>
        </p:blipFill>
        <p:spPr bwMode="auto">
          <a:xfrm>
            <a:off x="976251" y="942538"/>
            <a:ext cx="7163222" cy="4808332"/>
          </a:xfrm>
          <a:prstGeom prst="rect">
            <a:avLst/>
          </a:prstGeom>
          <a:noFill/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4567939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C41AA-D141-205F-CB87-D5ED38B998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ttributes</a:t>
            </a:r>
            <a:endParaRPr lang="en-Z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45290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2073" y="618681"/>
            <a:ext cx="3069771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f-test or Screening Activity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6146" name="Picture 2" descr="Self-testing for HIV is getting high marks in Zimbabwe | WHO | Regional  Office for Africa">
            <a:extLst>
              <a:ext uri="{FF2B5EF4-FFF2-40B4-BE49-F238E27FC236}">
                <a16:creationId xmlns:a16="http://schemas.microsoft.com/office/drawing/2014/main" id="{794119A2-7B82-C6E6-A6FE-2F6BF327E8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6343" y="1252358"/>
            <a:ext cx="6283037" cy="41886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1938806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2073" y="618681"/>
            <a:ext cx="3069771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vider administered Test or Screening Activity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43A2F6D-650D-BEB9-B36F-85C10E8441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4510" y="1654249"/>
            <a:ext cx="6346704" cy="33849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11447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D3B18-D138-2961-25A1-77878AD6E9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PP</a:t>
            </a:r>
            <a:endParaRPr lang="en-Z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671605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2073" y="618681"/>
            <a:ext cx="3069771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p to help guide you through the self-test or screening activity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B83BFF9-11F8-4ADB-21C6-10EFDFD480DD}"/>
              </a:ext>
            </a:extLst>
          </p:cNvPr>
          <p:cNvGrpSpPr/>
          <p:nvPr/>
        </p:nvGrpSpPr>
        <p:grpSpPr>
          <a:xfrm>
            <a:off x="1453437" y="618681"/>
            <a:ext cx="6210300" cy="5437251"/>
            <a:chOff x="3768976" y="1105415"/>
            <a:chExt cx="4654049" cy="4647170"/>
          </a:xfrm>
        </p:grpSpPr>
        <p:pic>
          <p:nvPicPr>
            <p:cNvPr id="2" name="Google Shape;265;p36">
              <a:extLst>
                <a:ext uri="{FF2B5EF4-FFF2-40B4-BE49-F238E27FC236}">
                  <a16:creationId xmlns:a16="http://schemas.microsoft.com/office/drawing/2014/main" id="{B9573AA6-FAB7-417B-8E52-9F3DF5EAFF7E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t="9380" b="9404"/>
            <a:stretch/>
          </p:blipFill>
          <p:spPr>
            <a:xfrm>
              <a:off x="6905126" y="3080954"/>
              <a:ext cx="1517899" cy="267163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5" name="Google Shape;266;p36">
              <a:extLst>
                <a:ext uri="{FF2B5EF4-FFF2-40B4-BE49-F238E27FC236}">
                  <a16:creationId xmlns:a16="http://schemas.microsoft.com/office/drawing/2014/main" id="{FE2B2AB1-FD22-C8C2-774E-85E9B9D2F38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t="8998" b="9121"/>
            <a:stretch/>
          </p:blipFill>
          <p:spPr>
            <a:xfrm>
              <a:off x="3768976" y="1105415"/>
              <a:ext cx="1517899" cy="26936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6" name="Google Shape;271;p36">
              <a:extLst>
                <a:ext uri="{FF2B5EF4-FFF2-40B4-BE49-F238E27FC236}">
                  <a16:creationId xmlns:a16="http://schemas.microsoft.com/office/drawing/2014/main" id="{C433C52E-9514-666D-9C71-D786929B0E7E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t="9123" b="9562"/>
            <a:stretch/>
          </p:blipFill>
          <p:spPr>
            <a:xfrm>
              <a:off x="5375651" y="2116865"/>
              <a:ext cx="1440700" cy="25387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</p:grpSp>
    </p:spTree>
    <p:extLst>
      <p:ext uri="{BB962C8B-B14F-4D97-AF65-F5344CB8AC3E}">
        <p14:creationId xmlns:p14="http://schemas.microsoft.com/office/powerpoint/2010/main" val="183471861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2073" y="618681"/>
            <a:ext cx="3069771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p to help capture your health outcome information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B83BFF9-11F8-4ADB-21C6-10EFDFD480DD}"/>
              </a:ext>
            </a:extLst>
          </p:cNvPr>
          <p:cNvGrpSpPr/>
          <p:nvPr/>
        </p:nvGrpSpPr>
        <p:grpSpPr>
          <a:xfrm>
            <a:off x="1453437" y="618681"/>
            <a:ext cx="6210300" cy="5437251"/>
            <a:chOff x="3768976" y="1105415"/>
            <a:chExt cx="4654049" cy="4647170"/>
          </a:xfrm>
        </p:grpSpPr>
        <p:pic>
          <p:nvPicPr>
            <p:cNvPr id="2" name="Google Shape;265;p36">
              <a:extLst>
                <a:ext uri="{FF2B5EF4-FFF2-40B4-BE49-F238E27FC236}">
                  <a16:creationId xmlns:a16="http://schemas.microsoft.com/office/drawing/2014/main" id="{B9573AA6-FAB7-417B-8E52-9F3DF5EAFF7E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t="9380" b="9404"/>
            <a:stretch/>
          </p:blipFill>
          <p:spPr>
            <a:xfrm>
              <a:off x="6905126" y="3080954"/>
              <a:ext cx="1517899" cy="267163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5" name="Google Shape;266;p36">
              <a:extLst>
                <a:ext uri="{FF2B5EF4-FFF2-40B4-BE49-F238E27FC236}">
                  <a16:creationId xmlns:a16="http://schemas.microsoft.com/office/drawing/2014/main" id="{FE2B2AB1-FD22-C8C2-774E-85E9B9D2F38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t="8998" b="9121"/>
            <a:stretch/>
          </p:blipFill>
          <p:spPr>
            <a:xfrm>
              <a:off x="3768976" y="1105415"/>
              <a:ext cx="1517899" cy="26936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6" name="Google Shape;271;p36">
              <a:extLst>
                <a:ext uri="{FF2B5EF4-FFF2-40B4-BE49-F238E27FC236}">
                  <a16:creationId xmlns:a16="http://schemas.microsoft.com/office/drawing/2014/main" id="{C433C52E-9514-666D-9C71-D786929B0E7E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t="9123" b="9562"/>
            <a:stretch/>
          </p:blipFill>
          <p:spPr>
            <a:xfrm>
              <a:off x="5375651" y="2116865"/>
              <a:ext cx="1440700" cy="25387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</p:grpSp>
    </p:spTree>
    <p:extLst>
      <p:ext uri="{BB962C8B-B14F-4D97-AF65-F5344CB8AC3E}">
        <p14:creationId xmlns:p14="http://schemas.microsoft.com/office/powerpoint/2010/main" val="129084101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92073" y="618681"/>
            <a:ext cx="3069771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assistance from an App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B83BFF9-11F8-4ADB-21C6-10EFDFD480DD}"/>
              </a:ext>
            </a:extLst>
          </p:cNvPr>
          <p:cNvGrpSpPr/>
          <p:nvPr/>
        </p:nvGrpSpPr>
        <p:grpSpPr>
          <a:xfrm>
            <a:off x="1453437" y="618681"/>
            <a:ext cx="6210300" cy="5437251"/>
            <a:chOff x="3768976" y="1105415"/>
            <a:chExt cx="4654049" cy="4647170"/>
          </a:xfrm>
        </p:grpSpPr>
        <p:pic>
          <p:nvPicPr>
            <p:cNvPr id="2" name="Google Shape;265;p36">
              <a:extLst>
                <a:ext uri="{FF2B5EF4-FFF2-40B4-BE49-F238E27FC236}">
                  <a16:creationId xmlns:a16="http://schemas.microsoft.com/office/drawing/2014/main" id="{B9573AA6-FAB7-417B-8E52-9F3DF5EAFF7E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 t="9380" b="9404"/>
            <a:stretch/>
          </p:blipFill>
          <p:spPr>
            <a:xfrm>
              <a:off x="6905126" y="3080954"/>
              <a:ext cx="1517899" cy="267163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5" name="Google Shape;266;p36">
              <a:extLst>
                <a:ext uri="{FF2B5EF4-FFF2-40B4-BE49-F238E27FC236}">
                  <a16:creationId xmlns:a16="http://schemas.microsoft.com/office/drawing/2014/main" id="{FE2B2AB1-FD22-C8C2-774E-85E9B9D2F387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t="8998" b="9121"/>
            <a:stretch/>
          </p:blipFill>
          <p:spPr>
            <a:xfrm>
              <a:off x="3768976" y="1105415"/>
              <a:ext cx="1517899" cy="26936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  <p:pic>
          <p:nvPicPr>
            <p:cNvPr id="6" name="Google Shape;271;p36">
              <a:extLst>
                <a:ext uri="{FF2B5EF4-FFF2-40B4-BE49-F238E27FC236}">
                  <a16:creationId xmlns:a16="http://schemas.microsoft.com/office/drawing/2014/main" id="{C433C52E-9514-666D-9C71-D786929B0E7E}"/>
                </a:ext>
              </a:extLst>
            </p:cNvPr>
            <p:cNvPicPr preferRelativeResize="0"/>
            <p:nvPr/>
          </p:nvPicPr>
          <p:blipFill rotWithShape="1">
            <a:blip r:embed="rId4">
              <a:alphaModFix/>
            </a:blip>
            <a:srcRect t="9123" b="9562"/>
            <a:stretch/>
          </p:blipFill>
          <p:spPr>
            <a:xfrm>
              <a:off x="5375651" y="2116865"/>
              <a:ext cx="1440700" cy="2538701"/>
            </a:xfrm>
            <a:prstGeom prst="rect">
              <a:avLst/>
            </a:prstGeom>
            <a:noFill/>
            <a:ln w="9525" cap="flat" cmpd="sng">
              <a:solidFill>
                <a:srgbClr val="999999"/>
              </a:solidFill>
              <a:prstDash val="solid"/>
              <a:round/>
              <a:headEnd type="none" w="sm" len="sm"/>
              <a:tailEnd type="none" w="sm" len="sm"/>
            </a:ln>
          </p:spPr>
        </p:pic>
      </p:grpSp>
    </p:spTree>
    <p:extLst>
      <p:ext uri="{BB962C8B-B14F-4D97-AF65-F5344CB8AC3E}">
        <p14:creationId xmlns:p14="http://schemas.microsoft.com/office/powerpoint/2010/main" val="69665800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D3B18-D138-2961-25A1-77878AD6E9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ealthcare Worker Assistance</a:t>
            </a:r>
            <a:endParaRPr lang="en-Z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29714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61937" y="484633"/>
            <a:ext cx="3071915" cy="5724144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lthcare worker to help guide you through the self-test or activity 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2A7CD1B-8A2D-6448-DE8D-94A17B97E7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2506" y="1677447"/>
            <a:ext cx="6401355" cy="367011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041A502-7936-D51C-87F0-E0A424C6BF20}"/>
              </a:ext>
            </a:extLst>
          </p:cNvPr>
          <p:cNvSpPr/>
          <p:nvPr/>
        </p:nvSpPr>
        <p:spPr>
          <a:xfrm>
            <a:off x="2892490" y="3023117"/>
            <a:ext cx="401215" cy="2705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>
              <a:ln>
                <a:solidFill>
                  <a:schemeClr val="bg1"/>
                </a:solidFill>
              </a:ln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1799374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4794567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laria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F23AC1CD-A288-E919-8847-A1A853A1A43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3234" b="-1753"/>
          <a:stretch/>
        </p:blipFill>
        <p:spPr>
          <a:xfrm>
            <a:off x="1679510" y="618681"/>
            <a:ext cx="5159829" cy="5417166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25080955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61937" y="484633"/>
            <a:ext cx="3071915" cy="5724144"/>
          </a:xfrm>
        </p:spPr>
        <p:txBody>
          <a:bodyPr>
            <a:normAutofit/>
          </a:bodyPr>
          <a:lstStyle/>
          <a:p>
            <a:r>
              <a:rPr lang="en-US" sz="32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lthcare worker available to help </a:t>
            </a:r>
            <a:r>
              <a:rPr lang="en-US" sz="3200" b="1" u="sng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ly if </a:t>
            </a:r>
            <a:r>
              <a:rPr lang="en-US" sz="32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ou need help while doing the self-test/activity</a:t>
            </a:r>
            <a:endParaRPr lang="en-ZA" sz="32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2A7CD1B-8A2D-6448-DE8D-94A17B97E7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2506" y="1677447"/>
            <a:ext cx="6401355" cy="367011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041A502-7936-D51C-87F0-E0A424C6BF20}"/>
              </a:ext>
            </a:extLst>
          </p:cNvPr>
          <p:cNvSpPr/>
          <p:nvPr/>
        </p:nvSpPr>
        <p:spPr>
          <a:xfrm>
            <a:off x="2892490" y="3023117"/>
            <a:ext cx="401215" cy="2705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ZA" sz="1800" b="0" i="0" u="none" strike="noStrike" kern="1200" cap="none" spc="0" normalizeH="0" baseline="0" noProof="0">
              <a:ln>
                <a:solidFill>
                  <a:prstClr val="white"/>
                </a:solidFill>
              </a:ln>
              <a:noFill/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6891678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61937" y="484633"/>
            <a:ext cx="3071915" cy="5724144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help from a Healthcare worker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041A502-7936-D51C-87F0-E0A424C6BF20}"/>
              </a:ext>
            </a:extLst>
          </p:cNvPr>
          <p:cNvSpPr/>
          <p:nvPr/>
        </p:nvSpPr>
        <p:spPr>
          <a:xfrm>
            <a:off x="2892490" y="3023117"/>
            <a:ext cx="401215" cy="2705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ZA" sz="1800" b="0" i="0" u="none" strike="noStrike" kern="1200" cap="none" spc="0" normalizeH="0" baseline="0" noProof="0">
              <a:ln>
                <a:solidFill>
                  <a:prstClr val="white"/>
                </a:solidFill>
              </a:ln>
              <a:noFill/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7" name="Picture 2" descr="1,400+ Hiv Test Illustrations, Royalty-Free Vector Graphics &amp; Clip Art -  iStock | At home hiv test, Oral hiv test">
            <a:extLst>
              <a:ext uri="{FF2B5EF4-FFF2-40B4-BE49-F238E27FC236}">
                <a16:creationId xmlns:a16="http://schemas.microsoft.com/office/drawing/2014/main" id="{8DA3E264-CB6D-B7FA-3735-FAD35115D9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2074" y="1675066"/>
            <a:ext cx="6396287" cy="36684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Flowchart: Summing Junction 2">
            <a:extLst>
              <a:ext uri="{FF2B5EF4-FFF2-40B4-BE49-F238E27FC236}">
                <a16:creationId xmlns:a16="http://schemas.microsoft.com/office/drawing/2014/main" id="{9F7C05D4-FA7D-96DC-B259-22E15BBA606B}"/>
              </a:ext>
            </a:extLst>
          </p:cNvPr>
          <p:cNvSpPr/>
          <p:nvPr/>
        </p:nvSpPr>
        <p:spPr>
          <a:xfrm>
            <a:off x="1679025" y="1062654"/>
            <a:ext cx="5086434" cy="4568100"/>
          </a:xfrm>
          <a:prstGeom prst="flowChartSummingJunction">
            <a:avLst/>
          </a:prstGeom>
          <a:noFill/>
          <a:ln w="762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673801-38B9-15FB-E8BA-D16158CC3A39}"/>
              </a:ext>
            </a:extLst>
          </p:cNvPr>
          <p:cNvSpPr/>
          <p:nvPr/>
        </p:nvSpPr>
        <p:spPr>
          <a:xfrm>
            <a:off x="3132057" y="3019085"/>
            <a:ext cx="401215" cy="27058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>
              <a:ln>
                <a:solidFill>
                  <a:schemeClr val="bg1"/>
                </a:solidFill>
              </a:ln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20288250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74D683-1FEE-DF68-F2E3-9A5C197D15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766218"/>
            <a:ext cx="10515600" cy="1325563"/>
          </a:xfrm>
        </p:spPr>
        <p:txBody>
          <a:bodyPr/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lace </a:t>
            </a:r>
            <a:endParaRPr lang="en-ZA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1510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484632"/>
            <a:ext cx="3038475" cy="5724144"/>
          </a:xfrm>
        </p:spPr>
        <p:txBody>
          <a:bodyPr>
            <a:normAutofit/>
          </a:bodyPr>
          <a:lstStyle/>
          <a:p>
            <a:b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one at your home</a:t>
            </a:r>
            <a:b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030" name="Picture 6" descr="Home House Silhouette Icon Building House - Home Clipart - Free Transparent  PNG Download - PNGkey">
            <a:extLst>
              <a:ext uri="{FF2B5EF4-FFF2-40B4-BE49-F238E27FC236}">
                <a16:creationId xmlns:a16="http://schemas.microsoft.com/office/drawing/2014/main" id="{FCB79D55-6FB3-7688-2035-145855A82B8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02" r="23536"/>
          <a:stretch/>
        </p:blipFill>
        <p:spPr bwMode="auto">
          <a:xfrm>
            <a:off x="2912042" y="1841649"/>
            <a:ext cx="3257849" cy="31747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2669197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1400174"/>
            <a:ext cx="3038475" cy="4013073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one at the clinic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050" name="Picture 2" descr="Hospital Silhouette Vector Art, Icons, and Graphics for Free Download">
            <a:extLst>
              <a:ext uri="{FF2B5EF4-FFF2-40B4-BE49-F238E27FC236}">
                <a16:creationId xmlns:a16="http://schemas.microsoft.com/office/drawing/2014/main" id="{6A523CE8-66A5-E552-7D2B-6E0DB19090D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8975" y="1236662"/>
            <a:ext cx="3907992" cy="39079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7865745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1400174"/>
            <a:ext cx="3038475" cy="4013073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one at a community hall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471A98F-CF6A-B6E4-66FC-6874A52DF2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0085" y="1458847"/>
            <a:ext cx="5829300" cy="3895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24168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1400174"/>
            <a:ext cx="3038475" cy="4013073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one at a mobile clinic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 descr="A picture containing outdoor, ground, sky, mountain&#10;&#10;Description automatically generated">
            <a:extLst>
              <a:ext uri="{FF2B5EF4-FFF2-40B4-BE49-F238E27FC236}">
                <a16:creationId xmlns:a16="http://schemas.microsoft.com/office/drawing/2014/main" id="{5E1CE970-62D1-95D7-E1E4-2C2E9B1EE7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2400" y="1382106"/>
            <a:ext cx="6142182" cy="4093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57392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484632"/>
            <a:ext cx="3038475" cy="5724144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 done at schools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2F19478-C0D6-D841-32C8-8070472C67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5485"/>
          <a:stretch/>
        </p:blipFill>
        <p:spPr>
          <a:xfrm>
            <a:off x="2522939" y="1293090"/>
            <a:ext cx="3896847" cy="35467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07762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4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48725" y="484632"/>
            <a:ext cx="3038475" cy="5724144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A3CCE56-5BAD-9A58-353B-A13F0E7258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7872" y="1617467"/>
            <a:ext cx="3458474" cy="3458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0514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B26A5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782050" y="1371600"/>
            <a:ext cx="2925318" cy="4041648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V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ACB1896-0412-27BA-5468-8858FF97D2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306" b="2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34309450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81665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ID-19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988D6F8-AF6F-D82A-AADB-6FB29623C74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45" r="3444" b="-2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3748924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825D5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4794567"/>
          </a:xfrm>
        </p:spPr>
        <p:txBody>
          <a:bodyPr>
            <a:normAutofit/>
          </a:bodyPr>
          <a:lstStyle/>
          <a:p>
            <a:r>
              <a:rPr lang="en-US" sz="3600" b="1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gnancy</a:t>
            </a:r>
            <a:endParaRPr lang="en-ZA" sz="3600" b="1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D667A8E-43B7-977D-53B6-8A35E34BDF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5456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9297723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C4877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5590095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od Glucose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CE8D3D1-9260-7B08-E9AC-37DF4B231E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0499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8522782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75605B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5724144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Is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994762-B4CB-106B-E505-CE8B4DB7B7E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7" r="3" b="3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28422656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7C615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4794567"/>
          </a:xfrm>
        </p:spPr>
        <p:txBody>
          <a:bodyPr>
            <a:normAutofit/>
          </a:bodyPr>
          <a:lstStyle/>
          <a:p>
            <a:r>
              <a:rPr lang="en-US" sz="3600" b="1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ood pressure</a:t>
            </a:r>
            <a:endParaRPr lang="en-ZA" sz="3600" b="1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8B9217E-56E2-3D43-9172-8A129EA9B6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539"/>
          <a:stretch/>
        </p:blipFill>
        <p:spPr>
          <a:xfrm>
            <a:off x="976251" y="942538"/>
            <a:ext cx="7163222" cy="4808332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29934696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3" name="Rectangle 4102">
            <a:extLst>
              <a:ext uri="{FF2B5EF4-FFF2-40B4-BE49-F238E27FC236}">
                <a16:creationId xmlns:a16="http://schemas.microsoft.com/office/drawing/2014/main" id="{16C5FA50-8D52-4617-AF91-5C7B1C8352F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292C5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0916918-AE38-4485-481E-755C256A8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93496" y="618681"/>
            <a:ext cx="2613872" cy="4794567"/>
          </a:xfrm>
        </p:spPr>
        <p:txBody>
          <a:bodyPr>
            <a:normAutofit/>
          </a:bodyPr>
          <a:lstStyle/>
          <a:p>
            <a:r>
              <a:rPr lang="en-US" sz="3600" b="1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ntal Health Screening</a:t>
            </a:r>
            <a:endParaRPr lang="en-ZA" sz="3600" b="1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5" name="Rounded Rectangle 9">
            <a:extLst>
              <a:ext uri="{FF2B5EF4-FFF2-40B4-BE49-F238E27FC236}">
                <a16:creationId xmlns:a16="http://schemas.microsoft.com/office/drawing/2014/main" id="{E223798C-12AD-4B0C-A50C-D676347D67C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93354" y="484632"/>
            <a:ext cx="8129016" cy="5724144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098" name="Picture 2" descr="Innovation for maternal mental health screening in South Africa | Mental  Health Innovation Network">
            <a:extLst>
              <a:ext uri="{FF2B5EF4-FFF2-40B4-BE49-F238E27FC236}">
                <a16:creationId xmlns:a16="http://schemas.microsoft.com/office/drawing/2014/main" id="{3603A8D2-8B3C-A412-5A0D-4F6C49CAECD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9" r="1" b="1"/>
          <a:stretch/>
        </p:blipFill>
        <p:spPr bwMode="auto">
          <a:xfrm>
            <a:off x="976251" y="942538"/>
            <a:ext cx="7163222" cy="4808332"/>
          </a:xfrm>
          <a:prstGeom prst="rect">
            <a:avLst/>
          </a:prstGeom>
          <a:noFill/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3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8</TotalTime>
  <Words>123</Words>
  <Application>Microsoft Macintosh PowerPoint</Application>
  <PresentationFormat>Widescreen</PresentationFormat>
  <Paragraphs>28</Paragraphs>
  <Slides>2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Tests and Screening activity cards</vt:lpstr>
      <vt:lpstr>Malaria</vt:lpstr>
      <vt:lpstr>HIV</vt:lpstr>
      <vt:lpstr>COVID-19</vt:lpstr>
      <vt:lpstr>Pregnancy</vt:lpstr>
      <vt:lpstr>Blood Glucose</vt:lpstr>
      <vt:lpstr>STIs</vt:lpstr>
      <vt:lpstr>Blood pressure</vt:lpstr>
      <vt:lpstr>Mental Health Screening</vt:lpstr>
      <vt:lpstr>Physical Health Screening</vt:lpstr>
      <vt:lpstr>Attributes</vt:lpstr>
      <vt:lpstr>Self-test or Screening Activity</vt:lpstr>
      <vt:lpstr>Provider administered Test or Screening Activity</vt:lpstr>
      <vt:lpstr>APP</vt:lpstr>
      <vt:lpstr>App to help guide you through the self-test or screening activity</vt:lpstr>
      <vt:lpstr>App to help capture your health outcome information</vt:lpstr>
      <vt:lpstr>No assistance from an App</vt:lpstr>
      <vt:lpstr>Healthcare Worker Assistance</vt:lpstr>
      <vt:lpstr>Healthcare worker to help guide you through the self-test or activity </vt:lpstr>
      <vt:lpstr>Healthcare worker available to help only if you need help while doing the self-test/activity</vt:lpstr>
      <vt:lpstr>No help from a Healthcare worker</vt:lpstr>
      <vt:lpstr>Place </vt:lpstr>
      <vt:lpstr> Test done at your home  </vt:lpstr>
      <vt:lpstr>Test done at the clinic</vt:lpstr>
      <vt:lpstr>Test done at a community hall</vt:lpstr>
      <vt:lpstr>Test done at a mobile clinic</vt:lpstr>
      <vt:lpstr>Test done at schools</vt:lpstr>
      <vt:lpstr>Other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sts and Screening activity cards</dc:title>
  <dc:creator>Hilton Humphries</dc:creator>
  <cp:lastModifiedBy>Anjali Sharma</cp:lastModifiedBy>
  <cp:revision>2</cp:revision>
  <dcterms:created xsi:type="dcterms:W3CDTF">2023-04-02T15:03:46Z</dcterms:created>
  <dcterms:modified xsi:type="dcterms:W3CDTF">2023-04-10T07:58:09Z</dcterms:modified>
</cp:coreProperties>
</file>